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0"/>
  </p:notesMasterIdLst>
  <p:handoutMasterIdLst>
    <p:handoutMasterId r:id="rId21"/>
  </p:handoutMasterIdLst>
  <p:sldIdLst>
    <p:sldId id="278" r:id="rId2"/>
    <p:sldId id="279" r:id="rId3"/>
    <p:sldId id="309" r:id="rId4"/>
    <p:sldId id="310" r:id="rId5"/>
    <p:sldId id="311" r:id="rId6"/>
    <p:sldId id="312" r:id="rId7"/>
    <p:sldId id="313" r:id="rId8"/>
    <p:sldId id="285" r:id="rId9"/>
    <p:sldId id="286" r:id="rId10"/>
    <p:sldId id="287" r:id="rId11"/>
    <p:sldId id="288" r:id="rId12"/>
    <p:sldId id="289" r:id="rId13"/>
    <p:sldId id="280" r:id="rId14"/>
    <p:sldId id="281" r:id="rId15"/>
    <p:sldId id="282" r:id="rId16"/>
    <p:sldId id="283" r:id="rId17"/>
    <p:sldId id="284" r:id="rId18"/>
    <p:sldId id="314" r:id="rId19"/>
  </p:sldIdLst>
  <p:sldSz cx="6858000" cy="9144000" type="screen4x3"/>
  <p:notesSz cx="9874250" cy="6797675"/>
  <p:defaultTextStyle>
    <a:defPPr>
      <a:defRPr lang="zh-TW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29" userDrawn="1">
          <p15:clr>
            <a:srgbClr val="A4A3A4"/>
          </p15:clr>
        </p15:guide>
        <p15:guide id="2" pos="177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824" autoAdjust="0"/>
    <p:restoredTop sz="88292" autoAdjust="0"/>
  </p:normalViewPr>
  <p:slideViewPr>
    <p:cSldViewPr snapToGrid="0" snapToObjects="1">
      <p:cViewPr varScale="1">
        <p:scale>
          <a:sx n="60" d="100"/>
          <a:sy n="60" d="100"/>
        </p:scale>
        <p:origin x="3160" y="184"/>
      </p:cViewPr>
      <p:guideLst>
        <p:guide orient="horz" pos="1429"/>
        <p:guide pos="177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handoutMaster" Target="handoutMasters/handout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969FC301-C496-4BC7-B9D5-C91045ED10B7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AA476354-67B4-4500-94B4-9CD8A3C386AE}">
      <dgm:prSet phldrT="[文字]" custT="1"/>
      <dgm:spPr>
        <a:solidFill>
          <a:schemeClr val="accent3">
            <a:alpha val="50000"/>
          </a:schemeClr>
        </a:solidFill>
      </dgm:spPr>
      <dgm:t>
        <a:bodyPr/>
        <a:lstStyle/>
        <a:p>
          <a:endParaRPr lang="zh-TW" altLang="en-US" sz="3200" dirty="0"/>
        </a:p>
      </dgm:t>
    </dgm:pt>
    <dgm:pt modelId="{5B2A156D-C37C-4F8C-A476-FE7F9DEFDE1E}" type="parTrans" cxnId="{A52D93E9-DA13-4313-AF61-D2F67E0B4945}">
      <dgm:prSet/>
      <dgm:spPr/>
      <dgm:t>
        <a:bodyPr/>
        <a:lstStyle/>
        <a:p>
          <a:endParaRPr lang="zh-TW" altLang="en-US"/>
        </a:p>
      </dgm:t>
    </dgm:pt>
    <dgm:pt modelId="{A59498F9-1F5D-4E6E-A83A-785D8EA1E3DD}" type="sibTrans" cxnId="{A52D93E9-DA13-4313-AF61-D2F67E0B4945}">
      <dgm:prSet/>
      <dgm:spPr/>
      <dgm:t>
        <a:bodyPr/>
        <a:lstStyle/>
        <a:p>
          <a:endParaRPr lang="zh-TW" altLang="en-US"/>
        </a:p>
      </dgm:t>
    </dgm:pt>
    <dgm:pt modelId="{0A613F88-9E1B-48BE-9019-F0FF72AD2385}">
      <dgm:prSet phldrT="[文字]" custT="1"/>
      <dgm:spPr>
        <a:solidFill>
          <a:schemeClr val="accent2">
            <a:alpha val="50000"/>
          </a:schemeClr>
        </a:solidFill>
      </dgm:spPr>
      <dgm:t>
        <a:bodyPr/>
        <a:lstStyle/>
        <a:p>
          <a:endParaRPr lang="zh-TW" altLang="en-US" sz="1400" dirty="0"/>
        </a:p>
      </dgm:t>
    </dgm:pt>
    <dgm:pt modelId="{9F4FA026-C8B1-4ABF-A2B5-F24EB2777AD0}" type="parTrans" cxnId="{E75AB961-D5FA-4E23-814F-8B44A687903F}">
      <dgm:prSet/>
      <dgm:spPr/>
      <dgm:t>
        <a:bodyPr/>
        <a:lstStyle/>
        <a:p>
          <a:endParaRPr lang="zh-TW" altLang="en-US"/>
        </a:p>
      </dgm:t>
    </dgm:pt>
    <dgm:pt modelId="{5554B080-969F-4691-9722-7293733C4611}" type="sibTrans" cxnId="{E75AB961-D5FA-4E23-814F-8B44A687903F}">
      <dgm:prSet/>
      <dgm:spPr/>
      <dgm:t>
        <a:bodyPr/>
        <a:lstStyle/>
        <a:p>
          <a:endParaRPr lang="zh-TW" altLang="en-US"/>
        </a:p>
      </dgm:t>
    </dgm:pt>
    <dgm:pt modelId="{050468F9-F5A7-48F0-8AD5-B5959C68EADA}">
      <dgm:prSet phldrT="[文字]" custT="1"/>
      <dgm:spPr/>
      <dgm:t>
        <a:bodyPr/>
        <a:lstStyle/>
        <a:p>
          <a:r>
            <a:rPr lang="en-US" sz="900" b="1" i="0" u="none" strike="noStrike" dirty="0" err="1">
              <a:solidFill>
                <a:schemeClr val="tx1"/>
              </a:solidFill>
              <a:latin typeface="Arial Unicode MS"/>
            </a:rPr>
            <a:t>Tallack</a:t>
          </a:r>
          <a:r>
            <a:rPr lang="en-US" sz="900" b="1" i="0" u="none" strike="noStrike" dirty="0">
              <a:solidFill>
                <a:schemeClr val="tx1"/>
              </a:solidFill>
              <a:latin typeface="Arial Unicode MS"/>
            </a:rPr>
            <a:t> </a:t>
          </a:r>
          <a:r>
            <a:rPr lang="en-US" sz="900" b="1" i="1" u="none" strike="noStrike" dirty="0">
              <a:solidFill>
                <a:schemeClr val="tx1"/>
              </a:solidFill>
              <a:latin typeface="Arial Unicode MS"/>
            </a:rPr>
            <a:t>et a</a:t>
          </a:r>
          <a:r>
            <a:rPr lang="en-US" sz="900" b="1" i="0" u="none" strike="noStrike" dirty="0">
              <a:solidFill>
                <a:schemeClr val="tx1"/>
              </a:solidFill>
              <a:latin typeface="Arial Unicode MS"/>
            </a:rPr>
            <a:t>l. (2010) </a:t>
          </a:r>
          <a:endParaRPr lang="zh-TW" altLang="en-US" sz="900" dirty="0">
            <a:solidFill>
              <a:schemeClr val="tx1"/>
            </a:solidFill>
          </a:endParaRPr>
        </a:p>
      </dgm:t>
    </dgm:pt>
    <dgm:pt modelId="{9060C124-3DDD-4A85-82AF-A00664F5CFCA}" type="sibTrans" cxnId="{4D0A7833-05C3-4ADB-AC76-323F6D822A16}">
      <dgm:prSet/>
      <dgm:spPr/>
      <dgm:t>
        <a:bodyPr/>
        <a:lstStyle/>
        <a:p>
          <a:endParaRPr lang="zh-TW" altLang="en-US"/>
        </a:p>
      </dgm:t>
    </dgm:pt>
    <dgm:pt modelId="{D7D14EBE-D574-41B0-A0F6-1689E90F3211}" type="parTrans" cxnId="{4D0A7833-05C3-4ADB-AC76-323F6D822A16}">
      <dgm:prSet/>
      <dgm:spPr/>
      <dgm:t>
        <a:bodyPr/>
        <a:lstStyle/>
        <a:p>
          <a:endParaRPr lang="zh-TW" altLang="en-US"/>
        </a:p>
      </dgm:t>
    </dgm:pt>
    <dgm:pt modelId="{47F0CAFB-60BE-45EE-8A19-C3127D9C1129}" type="pres">
      <dgm:prSet presAssocID="{969FC301-C496-4BC7-B9D5-C91045ED10B7}" presName="compositeShape" presStyleCnt="0">
        <dgm:presLayoutVars>
          <dgm:chMax val="7"/>
          <dgm:dir/>
          <dgm:resizeHandles val="exact"/>
        </dgm:presLayoutVars>
      </dgm:prSet>
      <dgm:spPr/>
    </dgm:pt>
    <dgm:pt modelId="{39E467BE-ED4B-4006-A5E4-A6625982D29D}" type="pres">
      <dgm:prSet presAssocID="{050468F9-F5A7-48F0-8AD5-B5959C68EADA}" presName="circ1" presStyleLbl="vennNode1" presStyleIdx="0" presStyleCnt="3" custScaleX="101376" custScaleY="96231" custLinFactNeighborX="-40108" custLinFactNeighborY="2703"/>
      <dgm:spPr/>
    </dgm:pt>
    <dgm:pt modelId="{2C42DB73-3341-4F0E-AEAE-7550E3D91023}" type="pres">
      <dgm:prSet presAssocID="{050468F9-F5A7-48F0-8AD5-B5959C68EADA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5331FAE2-F827-4059-A87D-A860042B8BD8}" type="pres">
      <dgm:prSet presAssocID="{AA476354-67B4-4500-94B4-9CD8A3C386AE}" presName="circ2" presStyleLbl="vennNode1" presStyleIdx="1" presStyleCnt="3" custScaleX="123297" custScaleY="112996" custLinFactNeighborX="-20314" custLinFactNeighborY="-223"/>
      <dgm:spPr/>
    </dgm:pt>
    <dgm:pt modelId="{90E07B21-CEE6-4A2E-920F-0F991A68DC3B}" type="pres">
      <dgm:prSet presAssocID="{AA476354-67B4-4500-94B4-9CD8A3C386AE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323A84E0-015A-4A9A-85AB-0A262CB38268}" type="pres">
      <dgm:prSet presAssocID="{0A613F88-9E1B-48BE-9019-F0FF72AD2385}" presName="circ3" presStyleLbl="vennNode1" presStyleIdx="2" presStyleCnt="3" custScaleX="77750" custScaleY="81448" custLinFactNeighborX="-25666" custLinFactNeighborY="1166"/>
      <dgm:spPr/>
    </dgm:pt>
    <dgm:pt modelId="{DF4CAB33-D5AE-4F17-AE38-694C74F04846}" type="pres">
      <dgm:prSet presAssocID="{0A613F88-9E1B-48BE-9019-F0FF72AD2385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C06B7A05-4610-489A-B501-2B26598DE816}" type="presOf" srcId="{969FC301-C496-4BC7-B9D5-C91045ED10B7}" destId="{47F0CAFB-60BE-45EE-8A19-C3127D9C1129}" srcOrd="0" destOrd="0" presId="urn:microsoft.com/office/officeart/2005/8/layout/venn1"/>
    <dgm:cxn modelId="{E6AC3829-5B82-4847-AAF9-059B0BB10F3D}" type="presOf" srcId="{050468F9-F5A7-48F0-8AD5-B5959C68EADA}" destId="{39E467BE-ED4B-4006-A5E4-A6625982D29D}" srcOrd="0" destOrd="0" presId="urn:microsoft.com/office/officeart/2005/8/layout/venn1"/>
    <dgm:cxn modelId="{4D0A7833-05C3-4ADB-AC76-323F6D822A16}" srcId="{969FC301-C496-4BC7-B9D5-C91045ED10B7}" destId="{050468F9-F5A7-48F0-8AD5-B5959C68EADA}" srcOrd="0" destOrd="0" parTransId="{D7D14EBE-D574-41B0-A0F6-1689E90F3211}" sibTransId="{9060C124-3DDD-4A85-82AF-A00664F5CFCA}"/>
    <dgm:cxn modelId="{EA5BC55D-019F-4A4F-808A-5D2E36379007}" type="presOf" srcId="{AA476354-67B4-4500-94B4-9CD8A3C386AE}" destId="{90E07B21-CEE6-4A2E-920F-0F991A68DC3B}" srcOrd="1" destOrd="0" presId="urn:microsoft.com/office/officeart/2005/8/layout/venn1"/>
    <dgm:cxn modelId="{78636D5E-8901-4D63-8F7C-D386C795CB84}" type="presOf" srcId="{AA476354-67B4-4500-94B4-9CD8A3C386AE}" destId="{5331FAE2-F827-4059-A87D-A860042B8BD8}" srcOrd="0" destOrd="0" presId="urn:microsoft.com/office/officeart/2005/8/layout/venn1"/>
    <dgm:cxn modelId="{E75AB961-D5FA-4E23-814F-8B44A687903F}" srcId="{969FC301-C496-4BC7-B9D5-C91045ED10B7}" destId="{0A613F88-9E1B-48BE-9019-F0FF72AD2385}" srcOrd="2" destOrd="0" parTransId="{9F4FA026-C8B1-4ABF-A2B5-F24EB2777AD0}" sibTransId="{5554B080-969F-4691-9722-7293733C4611}"/>
    <dgm:cxn modelId="{2E477EA7-41F6-4E06-B8DC-C1131DBB2171}" type="presOf" srcId="{0A613F88-9E1B-48BE-9019-F0FF72AD2385}" destId="{DF4CAB33-D5AE-4F17-AE38-694C74F04846}" srcOrd="1" destOrd="0" presId="urn:microsoft.com/office/officeart/2005/8/layout/venn1"/>
    <dgm:cxn modelId="{367952AE-4FBD-4FD4-B4F0-DABB7ECEC34E}" type="presOf" srcId="{050468F9-F5A7-48F0-8AD5-B5959C68EADA}" destId="{2C42DB73-3341-4F0E-AEAE-7550E3D91023}" srcOrd="1" destOrd="0" presId="urn:microsoft.com/office/officeart/2005/8/layout/venn1"/>
    <dgm:cxn modelId="{A52D93E9-DA13-4313-AF61-D2F67E0B4945}" srcId="{969FC301-C496-4BC7-B9D5-C91045ED10B7}" destId="{AA476354-67B4-4500-94B4-9CD8A3C386AE}" srcOrd="1" destOrd="0" parTransId="{5B2A156D-C37C-4F8C-A476-FE7F9DEFDE1E}" sibTransId="{A59498F9-1F5D-4E6E-A83A-785D8EA1E3DD}"/>
    <dgm:cxn modelId="{E2AC6DFF-47E8-44A5-ADF7-C1E8012AF735}" type="presOf" srcId="{0A613F88-9E1B-48BE-9019-F0FF72AD2385}" destId="{323A84E0-015A-4A9A-85AB-0A262CB38268}" srcOrd="0" destOrd="0" presId="urn:microsoft.com/office/officeart/2005/8/layout/venn1"/>
    <dgm:cxn modelId="{D2D03E19-1B82-4EAE-A260-CE10D8EE7EC4}" type="presParOf" srcId="{47F0CAFB-60BE-45EE-8A19-C3127D9C1129}" destId="{39E467BE-ED4B-4006-A5E4-A6625982D29D}" srcOrd="0" destOrd="0" presId="urn:microsoft.com/office/officeart/2005/8/layout/venn1"/>
    <dgm:cxn modelId="{2185430E-6A09-40FA-8BAD-0DC3FA35C05A}" type="presParOf" srcId="{47F0CAFB-60BE-45EE-8A19-C3127D9C1129}" destId="{2C42DB73-3341-4F0E-AEAE-7550E3D91023}" srcOrd="1" destOrd="0" presId="urn:microsoft.com/office/officeart/2005/8/layout/venn1"/>
    <dgm:cxn modelId="{60908826-FDC9-4A2B-B07C-3A2E44E153E6}" type="presParOf" srcId="{47F0CAFB-60BE-45EE-8A19-C3127D9C1129}" destId="{5331FAE2-F827-4059-A87D-A860042B8BD8}" srcOrd="2" destOrd="0" presId="urn:microsoft.com/office/officeart/2005/8/layout/venn1"/>
    <dgm:cxn modelId="{FD7C3D06-2795-483F-8E12-3F4C13361843}" type="presParOf" srcId="{47F0CAFB-60BE-45EE-8A19-C3127D9C1129}" destId="{90E07B21-CEE6-4A2E-920F-0F991A68DC3B}" srcOrd="3" destOrd="0" presId="urn:microsoft.com/office/officeart/2005/8/layout/venn1"/>
    <dgm:cxn modelId="{CF0672E0-53F6-4201-A103-51A66B53E206}" type="presParOf" srcId="{47F0CAFB-60BE-45EE-8A19-C3127D9C1129}" destId="{323A84E0-015A-4A9A-85AB-0A262CB38268}" srcOrd="4" destOrd="0" presId="urn:microsoft.com/office/officeart/2005/8/layout/venn1"/>
    <dgm:cxn modelId="{D4363ACE-B58B-46F3-916A-A62C38F29998}" type="presParOf" srcId="{47F0CAFB-60BE-45EE-8A19-C3127D9C1129}" destId="{DF4CAB33-D5AE-4F17-AE38-694C74F04846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9E467BE-ED4B-4006-A5E4-A6625982D29D}">
      <dsp:nvSpPr>
        <dsp:cNvPr id="0" name=""/>
        <dsp:cNvSpPr/>
      </dsp:nvSpPr>
      <dsp:spPr>
        <a:xfrm>
          <a:off x="381820" y="44787"/>
          <a:ext cx="1831090" cy="1738159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b="1" i="0" u="none" strike="noStrike" kern="1200" dirty="0" err="1">
              <a:solidFill>
                <a:schemeClr val="tx1"/>
              </a:solidFill>
              <a:latin typeface="Arial Unicode MS"/>
            </a:rPr>
            <a:t>Tallack</a:t>
          </a:r>
          <a:r>
            <a:rPr lang="en-US" sz="900" b="1" i="0" u="none" strike="noStrike" kern="1200" dirty="0">
              <a:solidFill>
                <a:schemeClr val="tx1"/>
              </a:solidFill>
              <a:latin typeface="Arial Unicode MS"/>
            </a:rPr>
            <a:t> </a:t>
          </a:r>
          <a:r>
            <a:rPr lang="en-US" sz="900" b="1" i="1" u="none" strike="noStrike" kern="1200" dirty="0">
              <a:solidFill>
                <a:schemeClr val="tx1"/>
              </a:solidFill>
              <a:latin typeface="Arial Unicode MS"/>
            </a:rPr>
            <a:t>et a</a:t>
          </a:r>
          <a:r>
            <a:rPr lang="en-US" sz="900" b="1" i="0" u="none" strike="noStrike" kern="1200" dirty="0">
              <a:solidFill>
                <a:schemeClr val="tx1"/>
              </a:solidFill>
              <a:latin typeface="Arial Unicode MS"/>
            </a:rPr>
            <a:t>l. (2010) </a:t>
          </a:r>
          <a:endParaRPr lang="zh-TW" altLang="en-US" sz="900" kern="1200" dirty="0">
            <a:solidFill>
              <a:schemeClr val="tx1"/>
            </a:solidFill>
          </a:endParaRPr>
        </a:p>
      </dsp:txBody>
      <dsp:txXfrm>
        <a:off x="625966" y="348965"/>
        <a:ext cx="1342799" cy="782171"/>
      </dsp:txXfrm>
    </dsp:sp>
    <dsp:sp modelId="{5331FAE2-F827-4059-A87D-A860042B8BD8}">
      <dsp:nvSpPr>
        <dsp:cNvPr id="0" name=""/>
        <dsp:cNvSpPr/>
      </dsp:nvSpPr>
      <dsp:spPr>
        <a:xfrm>
          <a:off x="1193125" y="969426"/>
          <a:ext cx="2227035" cy="2040974"/>
        </a:xfrm>
        <a:prstGeom prst="ellipse">
          <a:avLst/>
        </a:prstGeom>
        <a:solidFill>
          <a:schemeClr val="accent3">
            <a:alpha val="5000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zh-TW" altLang="en-US" sz="3200" kern="1200" dirty="0"/>
        </a:p>
      </dsp:txBody>
      <dsp:txXfrm>
        <a:off x="1874226" y="1496678"/>
        <a:ext cx="1336221" cy="1122536"/>
      </dsp:txXfrm>
    </dsp:sp>
    <dsp:sp modelId="{323A84E0-015A-4A9A-85AB-0A262CB38268}">
      <dsp:nvSpPr>
        <dsp:cNvPr id="0" name=""/>
        <dsp:cNvSpPr/>
      </dsp:nvSpPr>
      <dsp:spPr>
        <a:xfrm>
          <a:off x="204298" y="1279430"/>
          <a:ext cx="1404348" cy="1471143"/>
        </a:xfrm>
        <a:prstGeom prst="ellipse">
          <a:avLst/>
        </a:prstGeom>
        <a:solidFill>
          <a:schemeClr val="accent2">
            <a:alpha val="5000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zh-TW" altLang="en-US" sz="1400" kern="1200" dirty="0"/>
        </a:p>
      </dsp:txBody>
      <dsp:txXfrm>
        <a:off x="336540" y="1659476"/>
        <a:ext cx="842609" cy="80912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>
            <a:extLst>
              <a:ext uri="{FF2B5EF4-FFF2-40B4-BE49-F238E27FC236}">
                <a16:creationId xmlns:a16="http://schemas.microsoft.com/office/drawing/2014/main" id="{D3E12CF3-17F8-F047-BD36-B1C7A2CDF76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9918" cy="3409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89D8E2E2-016E-B847-B011-3B2B38483F88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592027" y="0"/>
            <a:ext cx="4279918" cy="3409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4912D1-B648-7E42-9904-7A99B06431D8}" type="datetimeFigureOut">
              <a:rPr kumimoji="1" lang="zh-TW" altLang="en-US" smtClean="0"/>
              <a:t>2021/6/10</a:t>
            </a:fld>
            <a:endParaRPr kumimoji="1"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0E363946-D0CB-B54B-8F0E-FBB7518EC834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6456698"/>
            <a:ext cx="4279918" cy="34097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E21B2698-7827-A241-A78D-1D360C99DCA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592027" y="6456698"/>
            <a:ext cx="4279918" cy="34097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89CA4F-937D-934D-B2F6-B60683E47706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2253089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2" y="3"/>
            <a:ext cx="4278841" cy="33988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5593126" y="3"/>
            <a:ext cx="4278841" cy="33988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03936B-5312-8440-8434-FBAE000040AC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3981450" y="509588"/>
            <a:ext cx="1911350" cy="2549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987426" y="3228898"/>
            <a:ext cx="7899400" cy="305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2" y="6456613"/>
            <a:ext cx="4278841" cy="33988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5593126" y="6456613"/>
            <a:ext cx="4278841" cy="33988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36FB49-8284-2C41-9DA5-5A19E19883A0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943517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1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10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7D5801-2440-8346-B358-8BC8183F71B7}" type="slidenum">
              <a:rPr kumimoji="1" lang="zh-TW" altLang="en-US" smtClean="0"/>
              <a:pPr/>
              <a:t>11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430361649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12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13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14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15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16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17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2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3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4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5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6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7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8</a:t>
            </a:fld>
            <a:endParaRPr kumimoji="1" lang="zh-TW" alt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3981450" y="509588"/>
            <a:ext cx="1911350" cy="2549525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FB49-8284-2C41-9DA5-5A19E19883A0}" type="slidenum">
              <a:rPr kumimoji="1" lang="zh-TW" altLang="en-US" smtClean="0"/>
              <a:pPr/>
              <a:t>9</a:t>
            </a:fld>
            <a:endParaRPr kumimoji="1" lang="zh-TW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78"/>
            <a:ext cx="5829300" cy="1960033"/>
          </a:xfrm>
        </p:spPr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子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9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1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3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6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TW" altLang="en-US"/>
              <a:t> 按一下以編輯母片子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48320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261981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257181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140344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941504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2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3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9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9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16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39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63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8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45671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257178" y="2844803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2628903" y="2844803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400626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33" indent="0">
              <a:buNone/>
              <a:defRPr sz="2000" b="1"/>
            </a:lvl2pPr>
            <a:lvl3pPr marL="914466" indent="0">
              <a:buNone/>
              <a:defRPr sz="1800" b="1"/>
            </a:lvl3pPr>
            <a:lvl4pPr marL="1371699" indent="0">
              <a:buNone/>
              <a:defRPr sz="1600" b="1"/>
            </a:lvl4pPr>
            <a:lvl5pPr marL="1828931" indent="0">
              <a:buNone/>
              <a:defRPr sz="1600" b="1"/>
            </a:lvl5pPr>
            <a:lvl6pPr marL="2286164" indent="0">
              <a:buNone/>
              <a:defRPr sz="1600" b="1"/>
            </a:lvl6pPr>
            <a:lvl7pPr marL="2743397" indent="0">
              <a:buNone/>
              <a:defRPr sz="1600" b="1"/>
            </a:lvl7pPr>
            <a:lvl8pPr marL="3200630" indent="0">
              <a:buNone/>
              <a:defRPr sz="1600" b="1"/>
            </a:lvl8pPr>
            <a:lvl9pPr marL="3657862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76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33" indent="0">
              <a:buNone/>
              <a:defRPr sz="2000" b="1"/>
            </a:lvl2pPr>
            <a:lvl3pPr marL="914466" indent="0">
              <a:buNone/>
              <a:defRPr sz="1800" b="1"/>
            </a:lvl3pPr>
            <a:lvl4pPr marL="1371699" indent="0">
              <a:buNone/>
              <a:defRPr sz="1600" b="1"/>
            </a:lvl4pPr>
            <a:lvl5pPr marL="1828931" indent="0">
              <a:buNone/>
              <a:defRPr sz="1600" b="1"/>
            </a:lvl5pPr>
            <a:lvl6pPr marL="2286164" indent="0">
              <a:buNone/>
              <a:defRPr sz="1600" b="1"/>
            </a:lvl6pPr>
            <a:lvl7pPr marL="2743397" indent="0">
              <a:buNone/>
              <a:defRPr sz="1600" b="1"/>
            </a:lvl7pPr>
            <a:lvl8pPr marL="3200630" indent="0">
              <a:buNone/>
              <a:defRPr sz="1600" b="1"/>
            </a:lvl8pPr>
            <a:lvl9pPr marL="3657862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76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9073896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982572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841097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7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94" y="36407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7" y="191347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33" indent="0">
              <a:buNone/>
              <a:defRPr sz="1200"/>
            </a:lvl2pPr>
            <a:lvl3pPr marL="914466" indent="0">
              <a:buNone/>
              <a:defRPr sz="1000"/>
            </a:lvl3pPr>
            <a:lvl4pPr marL="1371699" indent="0">
              <a:buNone/>
              <a:defRPr sz="900"/>
            </a:lvl4pPr>
            <a:lvl5pPr marL="1828931" indent="0">
              <a:buNone/>
              <a:defRPr sz="900"/>
            </a:lvl5pPr>
            <a:lvl6pPr marL="2286164" indent="0">
              <a:buNone/>
              <a:defRPr sz="900"/>
            </a:lvl6pPr>
            <a:lvl7pPr marL="2743397" indent="0">
              <a:buNone/>
              <a:defRPr sz="900"/>
            </a:lvl7pPr>
            <a:lvl8pPr marL="3200630" indent="0">
              <a:buNone/>
              <a:defRPr sz="900"/>
            </a:lvl8pPr>
            <a:lvl9pPr marL="3657862" indent="0">
              <a:buNone/>
              <a:defRPr sz="9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220279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3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33" indent="0">
              <a:buNone/>
              <a:defRPr sz="2800"/>
            </a:lvl2pPr>
            <a:lvl3pPr marL="914466" indent="0">
              <a:buNone/>
              <a:defRPr sz="2400"/>
            </a:lvl3pPr>
            <a:lvl4pPr marL="1371699" indent="0">
              <a:buNone/>
              <a:defRPr sz="2000"/>
            </a:lvl4pPr>
            <a:lvl5pPr marL="1828931" indent="0">
              <a:buNone/>
              <a:defRPr sz="2000"/>
            </a:lvl5pPr>
            <a:lvl6pPr marL="2286164" indent="0">
              <a:buNone/>
              <a:defRPr sz="2000"/>
            </a:lvl6pPr>
            <a:lvl7pPr marL="2743397" indent="0">
              <a:buNone/>
              <a:defRPr sz="2000"/>
            </a:lvl7pPr>
            <a:lvl8pPr marL="3200630" indent="0">
              <a:buNone/>
              <a:defRPr sz="2000"/>
            </a:lvl8pPr>
            <a:lvl9pPr marL="3657862" indent="0">
              <a:buNone/>
              <a:defRPr sz="2000"/>
            </a:lvl9pPr>
          </a:lstStyle>
          <a:p>
            <a:endParaRPr kumimoji="1"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4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33" indent="0">
              <a:buNone/>
              <a:defRPr sz="1200"/>
            </a:lvl2pPr>
            <a:lvl3pPr marL="914466" indent="0">
              <a:buNone/>
              <a:defRPr sz="1000"/>
            </a:lvl3pPr>
            <a:lvl4pPr marL="1371699" indent="0">
              <a:buNone/>
              <a:defRPr sz="900"/>
            </a:lvl4pPr>
            <a:lvl5pPr marL="1828931" indent="0">
              <a:buNone/>
              <a:defRPr sz="900"/>
            </a:lvl5pPr>
            <a:lvl6pPr marL="2286164" indent="0">
              <a:buNone/>
              <a:defRPr sz="900"/>
            </a:lvl6pPr>
            <a:lvl7pPr marL="2743397" indent="0">
              <a:buNone/>
              <a:defRPr sz="900"/>
            </a:lvl7pPr>
            <a:lvl8pPr marL="3200630" indent="0">
              <a:buNone/>
              <a:defRPr sz="900"/>
            </a:lvl8pPr>
            <a:lvl9pPr marL="3657862" indent="0">
              <a:buNone/>
              <a:defRPr sz="9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880407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1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4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3A508-6929-4B47-B2FD-67AEFB30BF02}" type="datetimeFigureOut">
              <a:rPr kumimoji="1" lang="zh-TW" altLang="en-US" smtClean="0"/>
              <a:pPr/>
              <a:t>2021/6/10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4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4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A2D6A8-B0F0-5041-9C99-B195F9E7B26F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386552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33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25" indent="-342925" algn="l" defTabSz="457233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3003" indent="-285771" algn="l" defTabSz="457233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82" indent="-228616" algn="l" defTabSz="457233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15" indent="-228616" algn="l" defTabSz="457233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548" indent="-228616" algn="l" defTabSz="457233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781" indent="-228616" algn="l" defTabSz="457233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2013" indent="-228616" algn="l" defTabSz="457233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246" indent="-228616" algn="l" defTabSz="457233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479" indent="-228616" algn="l" defTabSz="457233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4572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33" algn="l" defTabSz="4572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66" algn="l" defTabSz="4572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99" algn="l" defTabSz="4572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931" algn="l" defTabSz="4572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164" algn="l" defTabSz="4572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97" algn="l" defTabSz="4572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630" algn="l" defTabSz="4572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862" algn="l" defTabSz="4572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7" Type="http://schemas.openxmlformats.org/officeDocument/2006/relationships/hyperlink" Target="applewebdata://74CE0473-4DC7-4305-805F-5E556172D34A/#_ENREF_29" TargetMode="Externa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105_Output_Networks_P_1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440" y="1022024"/>
            <a:ext cx="5474382" cy="6565717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1" y="0"/>
            <a:ext cx="685799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92200" indent="-692200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1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Associated functional networks of up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52081" y="1160585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A)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94274854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>
            <a:extLst>
              <a:ext uri="{FF2B5EF4-FFF2-40B4-BE49-F238E27FC236}">
                <a16:creationId xmlns:a16="http://schemas.microsoft.com/office/drawing/2014/main" id="{FA7DD3A7-0242-3D44-BB2F-F5622AE659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32277"/>
            <a:ext cx="6858000" cy="8079446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52081" y="58369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C)</a:t>
            </a:r>
            <a:endParaRPr lang="zh-TW" altLang="en-US" dirty="0"/>
          </a:p>
        </p:txBody>
      </p:sp>
      <p:sp>
        <p:nvSpPr>
          <p:cNvPr id="6" name="矩形 5"/>
          <p:cNvSpPr/>
          <p:nvPr/>
        </p:nvSpPr>
        <p:spPr>
          <a:xfrm>
            <a:off x="5" y="0"/>
            <a:ext cx="617219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3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IPA identified significant canonical pathways associated with the up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29063126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 descr="103_Output_CanonicalPathways_N_4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" y="615729"/>
            <a:ext cx="6858000" cy="6145996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52081" y="58369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D)</a:t>
            </a:r>
            <a:endParaRPr lang="zh-TW" altLang="en-US" dirty="0"/>
          </a:p>
        </p:txBody>
      </p:sp>
      <p:sp>
        <p:nvSpPr>
          <p:cNvPr id="6" name="矩形 5"/>
          <p:cNvSpPr/>
          <p:nvPr/>
        </p:nvSpPr>
        <p:spPr>
          <a:xfrm>
            <a:off x="5" y="0"/>
            <a:ext cx="617219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3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IPA identified significant canonical pathways associated with the up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12471619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 descr="103_Output_CanonicalPathways_N_5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89802"/>
            <a:ext cx="6858000" cy="6809560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252081" y="583696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E)</a:t>
            </a:r>
            <a:endParaRPr lang="zh-TW" altLang="en-US" dirty="0"/>
          </a:p>
        </p:txBody>
      </p:sp>
      <p:sp>
        <p:nvSpPr>
          <p:cNvPr id="7" name="矩形 6"/>
          <p:cNvSpPr/>
          <p:nvPr/>
        </p:nvSpPr>
        <p:spPr>
          <a:xfrm>
            <a:off x="5" y="0"/>
            <a:ext cx="617219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3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IPA identified significant canonical pathways associated with the up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247656723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 descr="103_Output_CanonicalPathways_P_1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6658" y="960082"/>
            <a:ext cx="3524232" cy="6468231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3" y="0"/>
            <a:ext cx="622299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4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IPA identified significant canonical pathways associated with the down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52081" y="583696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A)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20785497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103_Output_CanonicalPathways_P_2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31393"/>
            <a:ext cx="6858000" cy="7025845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52081" y="583696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B)</a:t>
            </a:r>
            <a:endParaRPr lang="zh-TW" altLang="en-US" dirty="0"/>
          </a:p>
        </p:txBody>
      </p:sp>
      <p:sp>
        <p:nvSpPr>
          <p:cNvPr id="7" name="矩形 6"/>
          <p:cNvSpPr/>
          <p:nvPr/>
        </p:nvSpPr>
        <p:spPr>
          <a:xfrm>
            <a:off x="3" y="0"/>
            <a:ext cx="622299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4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IPA identified significant canonical pathways associated with the down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72269121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252081" y="58369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C)</a:t>
            </a:r>
            <a:endParaRPr lang="zh-TW" altLang="en-US" dirty="0"/>
          </a:p>
        </p:txBody>
      </p:sp>
      <p:sp>
        <p:nvSpPr>
          <p:cNvPr id="7" name="矩形 6"/>
          <p:cNvSpPr/>
          <p:nvPr/>
        </p:nvSpPr>
        <p:spPr>
          <a:xfrm>
            <a:off x="3" y="0"/>
            <a:ext cx="622299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4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IPA identified significant canonical pathways associated with the down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8E196469-4EC2-904F-84D0-6B65B3B9DA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553592"/>
            <a:ext cx="6858000" cy="56473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095939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103_Output_CanonicalPathways_P_4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78117"/>
            <a:ext cx="6858000" cy="3695785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252081" y="583696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D)</a:t>
            </a:r>
            <a:endParaRPr lang="zh-TW" altLang="en-US" dirty="0"/>
          </a:p>
        </p:txBody>
      </p:sp>
      <p:sp>
        <p:nvSpPr>
          <p:cNvPr id="6" name="矩形 5"/>
          <p:cNvSpPr/>
          <p:nvPr/>
        </p:nvSpPr>
        <p:spPr>
          <a:xfrm>
            <a:off x="3" y="0"/>
            <a:ext cx="622299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4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IPA identified significant canonical pathways associated with the down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214301698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103_Output_CanonicalPathways_P_5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066" y="690993"/>
            <a:ext cx="6409827" cy="7724661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52081" y="583696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E)</a:t>
            </a:r>
            <a:endParaRPr lang="zh-TW" altLang="en-US" dirty="0"/>
          </a:p>
        </p:txBody>
      </p:sp>
      <p:sp>
        <p:nvSpPr>
          <p:cNvPr id="6" name="矩形 5"/>
          <p:cNvSpPr/>
          <p:nvPr/>
        </p:nvSpPr>
        <p:spPr>
          <a:xfrm>
            <a:off x="3" y="0"/>
            <a:ext cx="622299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4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IPA identified significant canonical pathways associated with the down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180614890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EB17E6B7-3565-524F-8704-D2F27432348A}"/>
              </a:ext>
            </a:extLst>
          </p:cNvPr>
          <p:cNvSpPr txBox="1"/>
          <p:nvPr/>
        </p:nvSpPr>
        <p:spPr>
          <a:xfrm>
            <a:off x="609552" y="469885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B</a:t>
            </a:r>
            <a:endParaRPr lang="zh-TW" altLang="en-US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grpSp>
        <p:nvGrpSpPr>
          <p:cNvPr id="3" name="群組 2">
            <a:extLst>
              <a:ext uri="{FF2B5EF4-FFF2-40B4-BE49-F238E27FC236}">
                <a16:creationId xmlns:a16="http://schemas.microsoft.com/office/drawing/2014/main" id="{79EF66A4-DF56-404D-BDC2-47DC609C2392}"/>
              </a:ext>
            </a:extLst>
          </p:cNvPr>
          <p:cNvGrpSpPr>
            <a:grpSpLocks noChangeAspect="1"/>
          </p:cNvGrpSpPr>
          <p:nvPr/>
        </p:nvGrpSpPr>
        <p:grpSpPr>
          <a:xfrm>
            <a:off x="1138719" y="1329228"/>
            <a:ext cx="4454966" cy="3010394"/>
            <a:chOff x="13803" y="1105552"/>
            <a:chExt cx="5675798" cy="3835358"/>
          </a:xfrm>
        </p:grpSpPr>
        <p:grpSp>
          <p:nvGrpSpPr>
            <p:cNvPr id="4" name="群組 12">
              <a:extLst>
                <a:ext uri="{FF2B5EF4-FFF2-40B4-BE49-F238E27FC236}">
                  <a16:creationId xmlns:a16="http://schemas.microsoft.com/office/drawing/2014/main" id="{9AE7AB02-A14A-0844-9528-C68A1E69727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803" y="1105552"/>
              <a:ext cx="5675798" cy="3835358"/>
              <a:chOff x="13802" y="1867552"/>
              <a:chExt cx="7652571" cy="5171140"/>
            </a:xfrm>
          </p:grpSpPr>
          <p:graphicFrame>
            <p:nvGraphicFramePr>
              <p:cNvPr id="7" name="資料庫圖表 3">
                <a:extLst>
                  <a:ext uri="{FF2B5EF4-FFF2-40B4-BE49-F238E27FC236}">
                    <a16:creationId xmlns:a16="http://schemas.microsoft.com/office/drawing/2014/main" id="{2F2D788F-BC4B-B040-A847-DF482C87DC5A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680695591"/>
                  </p:ext>
                </p:extLst>
              </p:nvPr>
            </p:nvGraphicFramePr>
            <p:xfrm>
              <a:off x="13802" y="1867552"/>
              <a:ext cx="7652571" cy="5171140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2" r:lo="rId3" r:qs="rId4" r:cs="rId5"/>
              </a:graphicData>
            </a:graphic>
          </p:graphicFrame>
          <p:sp>
            <p:nvSpPr>
              <p:cNvPr id="8" name="文字方塊 7">
                <a:extLst>
                  <a:ext uri="{FF2B5EF4-FFF2-40B4-BE49-F238E27FC236}">
                    <a16:creationId xmlns:a16="http://schemas.microsoft.com/office/drawing/2014/main" id="{4C1778FE-F0DA-8346-A6A6-6A32BFD2BC8F}"/>
                  </a:ext>
                </a:extLst>
              </p:cNvPr>
              <p:cNvSpPr txBox="1"/>
              <p:nvPr/>
            </p:nvSpPr>
            <p:spPr>
              <a:xfrm>
                <a:off x="1699215" y="2505757"/>
                <a:ext cx="812855" cy="3965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1,144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9" name="文字方塊 8">
                <a:extLst>
                  <a:ext uri="{FF2B5EF4-FFF2-40B4-BE49-F238E27FC236}">
                    <a16:creationId xmlns:a16="http://schemas.microsoft.com/office/drawing/2014/main" id="{D308009B-FE8F-B645-8472-3DA80CCE946D}"/>
                  </a:ext>
                </a:extLst>
              </p:cNvPr>
              <p:cNvSpPr txBox="1"/>
              <p:nvPr/>
            </p:nvSpPr>
            <p:spPr>
              <a:xfrm>
                <a:off x="967091" y="5489551"/>
                <a:ext cx="647641" cy="3965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867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10" name="文字方塊 9">
                <a:extLst>
                  <a:ext uri="{FF2B5EF4-FFF2-40B4-BE49-F238E27FC236}">
                    <a16:creationId xmlns:a16="http://schemas.microsoft.com/office/drawing/2014/main" id="{C1C49EDA-E692-FC48-83AC-B1500DE36F50}"/>
                  </a:ext>
                </a:extLst>
              </p:cNvPr>
              <p:cNvSpPr txBox="1"/>
              <p:nvPr/>
            </p:nvSpPr>
            <p:spPr>
              <a:xfrm>
                <a:off x="3992547" y="5163150"/>
                <a:ext cx="812857" cy="3965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1,433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11" name="文字方塊 10">
                <a:extLst>
                  <a:ext uri="{FF2B5EF4-FFF2-40B4-BE49-F238E27FC236}">
                    <a16:creationId xmlns:a16="http://schemas.microsoft.com/office/drawing/2014/main" id="{6C7C5277-B733-9646-99DD-24AF4F9B4D08}"/>
                  </a:ext>
                </a:extLst>
              </p:cNvPr>
              <p:cNvSpPr txBox="1"/>
              <p:nvPr/>
            </p:nvSpPr>
            <p:spPr>
              <a:xfrm>
                <a:off x="2105643" y="4503432"/>
                <a:ext cx="537498" cy="3965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55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12" name="文字方塊 11">
                <a:extLst>
                  <a:ext uri="{FF2B5EF4-FFF2-40B4-BE49-F238E27FC236}">
                    <a16:creationId xmlns:a16="http://schemas.microsoft.com/office/drawing/2014/main" id="{78926304-ABBE-7346-9CAD-91BD40FF9AE8}"/>
                  </a:ext>
                </a:extLst>
              </p:cNvPr>
              <p:cNvSpPr txBox="1"/>
              <p:nvPr/>
            </p:nvSpPr>
            <p:spPr>
              <a:xfrm>
                <a:off x="2061039" y="5163150"/>
                <a:ext cx="647641" cy="3965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176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13" name="文字方塊 12">
                <a:extLst>
                  <a:ext uri="{FF2B5EF4-FFF2-40B4-BE49-F238E27FC236}">
                    <a16:creationId xmlns:a16="http://schemas.microsoft.com/office/drawing/2014/main" id="{C4382551-EDFB-434D-A519-D4E43FA426DD}"/>
                  </a:ext>
                </a:extLst>
              </p:cNvPr>
              <p:cNvSpPr txBox="1"/>
              <p:nvPr/>
            </p:nvSpPr>
            <p:spPr>
              <a:xfrm>
                <a:off x="1349841" y="4249473"/>
                <a:ext cx="647641" cy="3965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144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14" name="文字方塊 13">
                <a:extLst>
                  <a:ext uri="{FF2B5EF4-FFF2-40B4-BE49-F238E27FC236}">
                    <a16:creationId xmlns:a16="http://schemas.microsoft.com/office/drawing/2014/main" id="{BC1612B1-6B95-9E41-B17F-8726A6284A67}"/>
                  </a:ext>
                </a:extLst>
              </p:cNvPr>
              <p:cNvSpPr txBox="1"/>
              <p:nvPr/>
            </p:nvSpPr>
            <p:spPr>
              <a:xfrm>
                <a:off x="2694131" y="4032083"/>
                <a:ext cx="647641" cy="3965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202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</p:grp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268BFA08-21C5-EF40-98BC-73374BAA91EE}"/>
                </a:ext>
              </a:extLst>
            </p:cNvPr>
            <p:cNvSpPr/>
            <p:nvPr/>
          </p:nvSpPr>
          <p:spPr>
            <a:xfrm>
              <a:off x="247032" y="3440530"/>
              <a:ext cx="1427968" cy="29408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da-DK" altLang="zh-TW" sz="900" b="1" dirty="0" err="1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rPr>
                <a:t>Pilon</a:t>
              </a:r>
              <a:r>
                <a:rPr lang="da-DK" altLang="zh-TW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rPr>
                <a:t> </a:t>
              </a:r>
              <a:r>
                <a:rPr lang="da-DK" altLang="zh-TW" sz="900" b="1" i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rPr>
                <a:t>et al</a:t>
              </a:r>
              <a:r>
                <a:rPr lang="da-DK" altLang="zh-TW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rPr>
                <a:t>. (2011) </a:t>
              </a:r>
              <a:endParaRPr lang="zh-TW" altLang="en-US" sz="9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88D29ECB-3E92-B940-B1D6-A8FB592F9E2E}"/>
                </a:ext>
              </a:extLst>
            </p:cNvPr>
            <p:cNvSpPr/>
            <p:nvPr/>
          </p:nvSpPr>
          <p:spPr>
            <a:xfrm>
              <a:off x="2883088" y="3060442"/>
              <a:ext cx="766267" cy="4705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/>
              <a:r>
                <a:rPr lang="en-US" altLang="zh-TW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rPr>
                <a:t>Current </a:t>
              </a:r>
            </a:p>
            <a:p>
              <a:pPr lvl="0" algn="ctr"/>
              <a:r>
                <a:rPr lang="en-US" altLang="zh-TW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rPr>
                <a:t>Study</a:t>
              </a:r>
              <a:endParaRPr lang="zh-TW" altLang="en-US" sz="9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endParaRPr>
            </a:p>
          </p:txBody>
        </p:sp>
      </p:grp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2FD39A7C-86E9-BD4B-96EA-137811F62E56}"/>
              </a:ext>
            </a:extLst>
          </p:cNvPr>
          <p:cNvSpPr txBox="1"/>
          <p:nvPr/>
        </p:nvSpPr>
        <p:spPr>
          <a:xfrm>
            <a:off x="609551" y="103753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A</a:t>
            </a:r>
            <a:endParaRPr lang="zh-TW" altLang="en-US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grpSp>
        <p:nvGrpSpPr>
          <p:cNvPr id="15" name="群組 14">
            <a:extLst>
              <a:ext uri="{FF2B5EF4-FFF2-40B4-BE49-F238E27FC236}">
                <a16:creationId xmlns:a16="http://schemas.microsoft.com/office/drawing/2014/main" id="{B5809BFD-ED79-E44F-B087-DCFB6C158E4D}"/>
              </a:ext>
            </a:extLst>
          </p:cNvPr>
          <p:cNvGrpSpPr/>
          <p:nvPr/>
        </p:nvGrpSpPr>
        <p:grpSpPr>
          <a:xfrm>
            <a:off x="1412588" y="5383696"/>
            <a:ext cx="2401132" cy="2694403"/>
            <a:chOff x="1539386" y="5383695"/>
            <a:chExt cx="2401132" cy="2694403"/>
          </a:xfrm>
          <a:effectLst/>
        </p:grpSpPr>
        <p:grpSp>
          <p:nvGrpSpPr>
            <p:cNvPr id="32" name="群組 31">
              <a:extLst>
                <a:ext uri="{FF2B5EF4-FFF2-40B4-BE49-F238E27FC236}">
                  <a16:creationId xmlns:a16="http://schemas.microsoft.com/office/drawing/2014/main" id="{01C00795-1A3A-FC4A-A951-C86CB79261D8}"/>
                </a:ext>
              </a:extLst>
            </p:cNvPr>
            <p:cNvGrpSpPr/>
            <p:nvPr/>
          </p:nvGrpSpPr>
          <p:grpSpPr>
            <a:xfrm>
              <a:off x="1539386" y="5383695"/>
              <a:ext cx="2401132" cy="2694403"/>
              <a:chOff x="1403412" y="5224611"/>
              <a:chExt cx="2279555" cy="2609697"/>
            </a:xfrm>
            <a:effectLst/>
          </p:grpSpPr>
          <p:sp>
            <p:nvSpPr>
              <p:cNvPr id="18" name="橢圓 17">
                <a:extLst>
                  <a:ext uri="{FF2B5EF4-FFF2-40B4-BE49-F238E27FC236}">
                    <a16:creationId xmlns:a16="http://schemas.microsoft.com/office/drawing/2014/main" id="{E098DC7F-8B5E-584A-ACB5-EDE354F29143}"/>
                  </a:ext>
                </a:extLst>
              </p:cNvPr>
              <p:cNvSpPr/>
              <p:nvPr/>
            </p:nvSpPr>
            <p:spPr>
              <a:xfrm>
                <a:off x="1579209" y="5224611"/>
                <a:ext cx="1764066" cy="1695099"/>
              </a:xfrm>
              <a:prstGeom prst="ellipse">
                <a:avLst/>
              </a:prstGeom>
              <a:solidFill>
                <a:schemeClr val="tx2">
                  <a:lumMod val="40000"/>
                  <a:lumOff val="60000"/>
                  <a:alpha val="50000"/>
                </a:schemeClr>
              </a:solidFill>
              <a:ln w="12700"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 sz="900" b="1" dirty="0"/>
              </a:p>
            </p:txBody>
          </p:sp>
          <p:sp>
            <p:nvSpPr>
              <p:cNvPr id="20" name="橢圓 19">
                <a:extLst>
                  <a:ext uri="{FF2B5EF4-FFF2-40B4-BE49-F238E27FC236}">
                    <a16:creationId xmlns:a16="http://schemas.microsoft.com/office/drawing/2014/main" id="{E5E3F74F-64AC-3C4D-B2E5-C19F39C9EEA4}"/>
                  </a:ext>
                </a:extLst>
              </p:cNvPr>
              <p:cNvSpPr/>
              <p:nvPr/>
            </p:nvSpPr>
            <p:spPr>
              <a:xfrm>
                <a:off x="2503985" y="6438900"/>
                <a:ext cx="1178982" cy="1135854"/>
              </a:xfrm>
              <a:prstGeom prst="ellipse">
                <a:avLst/>
              </a:prstGeom>
              <a:solidFill>
                <a:schemeClr val="accent3">
                  <a:alpha val="48000"/>
                </a:schemeClr>
              </a:solidFill>
              <a:ln w="12700"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 sz="900" b="1" dirty="0"/>
              </a:p>
            </p:txBody>
          </p:sp>
          <p:sp>
            <p:nvSpPr>
              <p:cNvPr id="19" name="橢圓 18">
                <a:extLst>
                  <a:ext uri="{FF2B5EF4-FFF2-40B4-BE49-F238E27FC236}">
                    <a16:creationId xmlns:a16="http://schemas.microsoft.com/office/drawing/2014/main" id="{734A6598-2546-AE4F-A586-69A021F6642D}"/>
                  </a:ext>
                </a:extLst>
              </p:cNvPr>
              <p:cNvSpPr/>
              <p:nvPr/>
            </p:nvSpPr>
            <p:spPr>
              <a:xfrm>
                <a:off x="1403412" y="6438900"/>
                <a:ext cx="1366935" cy="1395408"/>
              </a:xfrm>
              <a:prstGeom prst="ellipse">
                <a:avLst/>
              </a:prstGeom>
              <a:solidFill>
                <a:schemeClr val="accent2">
                  <a:alpha val="44000"/>
                </a:schemeClr>
              </a:solidFill>
              <a:ln w="12700"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 sz="900" b="1" dirty="0"/>
              </a:p>
            </p:txBody>
          </p:sp>
        </p:grpSp>
        <p:grpSp>
          <p:nvGrpSpPr>
            <p:cNvPr id="31" name="群組 30">
              <a:extLst>
                <a:ext uri="{FF2B5EF4-FFF2-40B4-BE49-F238E27FC236}">
                  <a16:creationId xmlns:a16="http://schemas.microsoft.com/office/drawing/2014/main" id="{632DE81A-36C8-954D-87AA-CEB118AD5BB2}"/>
                </a:ext>
              </a:extLst>
            </p:cNvPr>
            <p:cNvGrpSpPr/>
            <p:nvPr/>
          </p:nvGrpSpPr>
          <p:grpSpPr>
            <a:xfrm>
              <a:off x="1597240" y="5821393"/>
              <a:ext cx="2149742" cy="1970136"/>
              <a:chOff x="1597240" y="5821393"/>
              <a:chExt cx="2149742" cy="1970136"/>
            </a:xfrm>
          </p:grpSpPr>
          <p:sp>
            <p:nvSpPr>
              <p:cNvPr id="21" name="文字方塊 20">
                <a:extLst>
                  <a:ext uri="{FF2B5EF4-FFF2-40B4-BE49-F238E27FC236}">
                    <a16:creationId xmlns:a16="http://schemas.microsoft.com/office/drawing/2014/main" id="{ABFE13C8-3939-9E4C-B357-44ACD02EE5D4}"/>
                  </a:ext>
                </a:extLst>
              </p:cNvPr>
              <p:cNvSpPr txBox="1"/>
              <p:nvPr/>
            </p:nvSpPr>
            <p:spPr>
              <a:xfrm>
                <a:off x="2414387" y="5821393"/>
                <a:ext cx="47320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1,144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22" name="文字方塊 21">
                <a:extLst>
                  <a:ext uri="{FF2B5EF4-FFF2-40B4-BE49-F238E27FC236}">
                    <a16:creationId xmlns:a16="http://schemas.microsoft.com/office/drawing/2014/main" id="{FD606DA8-413E-954A-ABA1-D55153BDBC5E}"/>
                  </a:ext>
                </a:extLst>
              </p:cNvPr>
              <p:cNvSpPr txBox="1"/>
              <p:nvPr/>
            </p:nvSpPr>
            <p:spPr>
              <a:xfrm>
                <a:off x="1953107" y="7560697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867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23" name="文字方塊 22">
                <a:extLst>
                  <a:ext uri="{FF2B5EF4-FFF2-40B4-BE49-F238E27FC236}">
                    <a16:creationId xmlns:a16="http://schemas.microsoft.com/office/drawing/2014/main" id="{D375CCD4-00CE-0741-AABA-8C84D5A4FC5F}"/>
                  </a:ext>
                </a:extLst>
              </p:cNvPr>
              <p:cNvSpPr txBox="1"/>
              <p:nvPr/>
            </p:nvSpPr>
            <p:spPr>
              <a:xfrm>
                <a:off x="3243978" y="7329865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351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24" name="文字方塊 23">
                <a:extLst>
                  <a:ext uri="{FF2B5EF4-FFF2-40B4-BE49-F238E27FC236}">
                    <a16:creationId xmlns:a16="http://schemas.microsoft.com/office/drawing/2014/main" id="{72B8258A-4DB1-DD4D-9DED-66B5C55E4B0B}"/>
                  </a:ext>
                </a:extLst>
              </p:cNvPr>
              <p:cNvSpPr txBox="1"/>
              <p:nvPr/>
            </p:nvSpPr>
            <p:spPr>
              <a:xfrm>
                <a:off x="2662141" y="6928000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24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25" name="文字方塊 24">
                <a:extLst>
                  <a:ext uri="{FF2B5EF4-FFF2-40B4-BE49-F238E27FC236}">
                    <a16:creationId xmlns:a16="http://schemas.microsoft.com/office/drawing/2014/main" id="{CE1D5950-B529-0E44-82C9-09436ADC5AF1}"/>
                  </a:ext>
                </a:extLst>
              </p:cNvPr>
              <p:cNvSpPr txBox="1"/>
              <p:nvPr/>
            </p:nvSpPr>
            <p:spPr>
              <a:xfrm>
                <a:off x="2690219" y="7246830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99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26" name="文字方塊 25">
                <a:extLst>
                  <a:ext uri="{FF2B5EF4-FFF2-40B4-BE49-F238E27FC236}">
                    <a16:creationId xmlns:a16="http://schemas.microsoft.com/office/drawing/2014/main" id="{0324F831-CD3C-C74E-B0CE-F833AF0F4D99}"/>
                  </a:ext>
                </a:extLst>
              </p:cNvPr>
              <p:cNvSpPr txBox="1"/>
              <p:nvPr/>
            </p:nvSpPr>
            <p:spPr>
              <a:xfrm>
                <a:off x="2154820" y="6741691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144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27" name="文字方塊 26">
                <a:extLst>
                  <a:ext uri="{FF2B5EF4-FFF2-40B4-BE49-F238E27FC236}">
                    <a16:creationId xmlns:a16="http://schemas.microsoft.com/office/drawing/2014/main" id="{5C3A9DC8-4F15-844C-895E-954E6183C0FB}"/>
                  </a:ext>
                </a:extLst>
              </p:cNvPr>
              <p:cNvSpPr txBox="1"/>
              <p:nvPr/>
            </p:nvSpPr>
            <p:spPr>
              <a:xfrm>
                <a:off x="2952851" y="6716676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126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9A574C52-4B72-4947-AEF9-52A865A99082}"/>
                  </a:ext>
                </a:extLst>
              </p:cNvPr>
              <p:cNvSpPr/>
              <p:nvPr/>
            </p:nvSpPr>
            <p:spPr>
              <a:xfrm>
                <a:off x="1597240" y="7215629"/>
                <a:ext cx="1088760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da-DK" altLang="zh-TW" sz="900" b="1" dirty="0" err="1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Pilon</a:t>
                </a:r>
                <a:r>
                  <a:rPr lang="da-DK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 </a:t>
                </a:r>
                <a:r>
                  <a:rPr lang="da-DK" altLang="zh-TW" sz="900" b="1" i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et al</a:t>
                </a:r>
                <a:r>
                  <a:rPr lang="da-DK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.(2011) 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71C6CB13-19C3-6E42-A73A-B3AE61AE1B27}"/>
                  </a:ext>
                </a:extLst>
              </p:cNvPr>
              <p:cNvSpPr/>
              <p:nvPr/>
            </p:nvSpPr>
            <p:spPr>
              <a:xfrm>
                <a:off x="3145535" y="7024813"/>
                <a:ext cx="601447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/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Current </a:t>
                </a:r>
              </a:p>
              <a:p>
                <a:pPr lvl="0" algn="ctr"/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Study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079EEBF7-E6F4-734A-A5FE-F1AF67099AEA}"/>
                  </a:ext>
                </a:extLst>
              </p:cNvPr>
              <p:cNvSpPr/>
              <p:nvPr/>
            </p:nvSpPr>
            <p:spPr>
              <a:xfrm>
                <a:off x="2064336" y="6049343"/>
                <a:ext cx="1197764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/>
                <a:r>
                  <a:rPr lang="en-US" altLang="zh-TW" sz="900" b="1" dirty="0" err="1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Tallack</a:t>
                </a:r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 </a:t>
                </a:r>
                <a:r>
                  <a:rPr lang="en-US" altLang="zh-TW" sz="900" b="1" i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et al</a:t>
                </a:r>
                <a:r>
                  <a:rPr lang="en-US" altLang="zh-TW" sz="900" b="1" dirty="0">
                    <a:latin typeface="Arial Unicode MS" pitchFamily="34" charset="-120"/>
                    <a:ea typeface="Arial Unicode MS" pitchFamily="34" charset="-120"/>
                    <a:cs typeface="Arial Unicode MS" pitchFamily="34" charset="-120"/>
                  </a:rPr>
                  <a:t>. (2010)</a:t>
                </a:r>
                <a:endParaRPr lang="zh-TW" altLang="en-US" sz="900" b="1" dirty="0">
                  <a:latin typeface="Arial Unicode MS" pitchFamily="34" charset="-120"/>
                  <a:ea typeface="Arial Unicode MS" pitchFamily="34" charset="-120"/>
                  <a:cs typeface="Arial Unicode MS" pitchFamily="34" charset="-120"/>
                </a:endParaRPr>
              </a:p>
            </p:txBody>
          </p:sp>
        </p:grpSp>
      </p:grpSp>
      <p:sp>
        <p:nvSpPr>
          <p:cNvPr id="33" name="矩形 32">
            <a:extLst>
              <a:ext uri="{FF2B5EF4-FFF2-40B4-BE49-F238E27FC236}">
                <a16:creationId xmlns:a16="http://schemas.microsoft.com/office/drawing/2014/main" id="{DC2D579E-3CD7-194D-896D-072755238F45}"/>
              </a:ext>
            </a:extLst>
          </p:cNvPr>
          <p:cNvSpPr/>
          <p:nvPr/>
        </p:nvSpPr>
        <p:spPr>
          <a:xfrm>
            <a:off x="3" y="21265"/>
            <a:ext cx="625194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69973" indent="-669973" defTabSz="91446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TW" sz="1400" b="1" dirty="0">
                <a:solidFill>
                  <a:srgbClr val="000000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Fig. S5. </a:t>
            </a:r>
            <a:r>
              <a:rPr lang="en-US" altLang="zh-TW" sz="1400" b="1" u="sng" dirty="0">
                <a:solidFill>
                  <a:srgbClr val="000000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Three-way Venn diagram displaying the overlap of direct targets of EKLF as derived from </a:t>
            </a:r>
            <a:r>
              <a:rPr lang="en-US" altLang="zh-TW" sz="1400" b="1" u="sng" dirty="0" err="1">
                <a:solidFill>
                  <a:srgbClr val="000000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Tallack</a:t>
            </a:r>
            <a:r>
              <a:rPr lang="en-US" altLang="zh-TW" sz="1400" b="1" u="sng" dirty="0">
                <a:solidFill>
                  <a:srgbClr val="000000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lang="en-US" altLang="zh-TW" sz="1400" b="1" i="1" u="sng" dirty="0">
                <a:solidFill>
                  <a:srgbClr val="000000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et al</a:t>
            </a:r>
            <a:r>
              <a:rPr lang="en-US" altLang="zh-TW" sz="1400" b="1" u="sng" dirty="0">
                <a:solidFill>
                  <a:srgbClr val="000000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. (2010) (</a:t>
            </a:r>
            <a:r>
              <a:rPr lang="en-US" altLang="zh-TW" sz="1400" b="1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  <a:hlinkClick r:id="rId7" tooltip="Tallack, 2010 #8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2</a:t>
            </a:r>
            <a:r>
              <a:rPr lang="en-US" altLang="zh-TW" sz="1400" b="1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8</a:t>
            </a:r>
            <a:r>
              <a:rPr lang="en-US" altLang="zh-TW" sz="1400" b="1" u="sng" dirty="0">
                <a:solidFill>
                  <a:srgbClr val="000000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), Pilon </a:t>
            </a:r>
            <a:r>
              <a:rPr lang="en-US" altLang="zh-TW" sz="1400" b="1" i="1" u="sng" dirty="0">
                <a:solidFill>
                  <a:srgbClr val="000000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et al</a:t>
            </a:r>
            <a:r>
              <a:rPr lang="en-US" altLang="zh-TW" sz="1400" b="1" u="sng" dirty="0">
                <a:solidFill>
                  <a:srgbClr val="000000"/>
                </a:solidFill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rPr>
              <a:t>. (2011) (29), and the current study.</a:t>
            </a:r>
            <a:endParaRPr lang="en-US" altLang="zh-TW" sz="2000" dirty="0">
              <a:latin typeface="Arial Unicode MS" panose="020B0604020202020204" pitchFamily="34" charset="-128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440500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105_Output_Networks_P_2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9332"/>
            <a:ext cx="6858000" cy="7276861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52081" y="1160585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B)</a:t>
            </a:r>
            <a:endParaRPr lang="zh-TW" altLang="en-US" dirty="0"/>
          </a:p>
        </p:txBody>
      </p:sp>
      <p:sp>
        <p:nvSpPr>
          <p:cNvPr id="6" name="矩形 5"/>
          <p:cNvSpPr/>
          <p:nvPr/>
        </p:nvSpPr>
        <p:spPr>
          <a:xfrm>
            <a:off x="1" y="0"/>
            <a:ext cx="685799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92200" indent="-692200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1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Associated functional networks of up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12485567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105_Output_Networks_N_1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2" r="3562"/>
          <a:stretch/>
        </p:blipFill>
        <p:spPr>
          <a:xfrm>
            <a:off x="0" y="675453"/>
            <a:ext cx="6858000" cy="6431915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0" y="0"/>
            <a:ext cx="6858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2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Associated functional networks of down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52081" y="1160585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A)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0123202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105_Output_Networks_N_2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911" y="867172"/>
            <a:ext cx="5426121" cy="7285779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52081" y="1160585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B)</a:t>
            </a:r>
            <a:endParaRPr lang="zh-TW" altLang="en-US" dirty="0"/>
          </a:p>
        </p:txBody>
      </p:sp>
      <p:sp>
        <p:nvSpPr>
          <p:cNvPr id="6" name="矩形 5"/>
          <p:cNvSpPr/>
          <p:nvPr/>
        </p:nvSpPr>
        <p:spPr>
          <a:xfrm>
            <a:off x="0" y="0"/>
            <a:ext cx="6858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2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Associated functional networks of down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11661003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105_Output_Networks_N_3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843" y="588437"/>
            <a:ext cx="6018772" cy="7463859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52081" y="1160585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C)</a:t>
            </a:r>
            <a:endParaRPr lang="zh-TW" altLang="en-US" dirty="0"/>
          </a:p>
        </p:txBody>
      </p:sp>
      <p:sp>
        <p:nvSpPr>
          <p:cNvPr id="6" name="矩形 5"/>
          <p:cNvSpPr/>
          <p:nvPr/>
        </p:nvSpPr>
        <p:spPr>
          <a:xfrm>
            <a:off x="0" y="0"/>
            <a:ext cx="6858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2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Associated functional networks of down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16574174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105_Output_Networks_N_4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559" y="926802"/>
            <a:ext cx="5122144" cy="6382207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52081" y="1160585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D)</a:t>
            </a:r>
            <a:endParaRPr lang="zh-TW" altLang="en-US" dirty="0"/>
          </a:p>
        </p:txBody>
      </p:sp>
      <p:sp>
        <p:nvSpPr>
          <p:cNvPr id="6" name="矩形 5"/>
          <p:cNvSpPr/>
          <p:nvPr/>
        </p:nvSpPr>
        <p:spPr>
          <a:xfrm>
            <a:off x="0" y="0"/>
            <a:ext cx="6858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2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Associated functional networks of down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16189283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 descr="105_Output_Networks_N_5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727" y="867173"/>
            <a:ext cx="5481527" cy="6503777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252081" y="1160585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E)</a:t>
            </a:r>
            <a:endParaRPr lang="zh-TW" altLang="en-US" dirty="0"/>
          </a:p>
        </p:txBody>
      </p:sp>
      <p:sp>
        <p:nvSpPr>
          <p:cNvPr id="6" name="矩形 5"/>
          <p:cNvSpPr/>
          <p:nvPr/>
        </p:nvSpPr>
        <p:spPr>
          <a:xfrm>
            <a:off x="0" y="0"/>
            <a:ext cx="6858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2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Associated functional networks of down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34497858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 descr="103_Output_CanonicalPathways_N_1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155" y="768362"/>
            <a:ext cx="5983896" cy="5730718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5" y="0"/>
            <a:ext cx="617219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3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IPA identified significant canonical pathways associated with the up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52081" y="583696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A)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21189064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 descr="103_Output_CanonicalPathways_N_2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9794" y="1120531"/>
            <a:ext cx="4130590" cy="5229145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252081" y="583696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(B)</a:t>
            </a:r>
            <a:endParaRPr lang="zh-TW" altLang="en-US" dirty="0"/>
          </a:p>
        </p:txBody>
      </p:sp>
      <p:sp>
        <p:nvSpPr>
          <p:cNvPr id="7" name="矩形 6"/>
          <p:cNvSpPr/>
          <p:nvPr/>
        </p:nvSpPr>
        <p:spPr>
          <a:xfrm>
            <a:off x="5" y="0"/>
            <a:ext cx="617219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85849" indent="-685849"/>
            <a:r>
              <a:rPr lang="en-US" altLang="zh-TW" sz="1400" b="1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Fig. S3. </a:t>
            </a:r>
            <a:r>
              <a:rPr lang="en-US" altLang="zh-TW" sz="1400" b="1" u="sng" dirty="0">
                <a:latin typeface="Arial Unicode MS" pitchFamily="34" charset="-120"/>
                <a:ea typeface="Arial Unicode MS" pitchFamily="34" charset="-120"/>
                <a:cs typeface="Arial Unicode MS" pitchFamily="34" charset="-120"/>
              </a:rPr>
              <a:t>IPA identified significant canonical pathways associated with the up-regulated EKLF targets in E14.5 fetal liver cells.</a:t>
            </a:r>
            <a:endParaRPr lang="zh-TW" altLang="en-US" sz="1400" b="1" dirty="0">
              <a:latin typeface="Arial Unicode MS" pitchFamily="34" charset="-120"/>
              <a:ea typeface="Arial Unicode MS" pitchFamily="34" charset="-120"/>
              <a:cs typeface="Arial Unicode MS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521594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81</TotalTime>
  <Words>487</Words>
  <Application>Microsoft Macintosh PowerPoint</Application>
  <PresentationFormat>如螢幕大小 (4:3)</PresentationFormat>
  <Paragraphs>76</Paragraphs>
  <Slides>18</Slides>
  <Notes>17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8</vt:i4>
      </vt:variant>
    </vt:vector>
  </HeadingPairs>
  <TitlesOfParts>
    <vt:vector size="23" baseType="lpstr">
      <vt:lpstr>新細明體</vt:lpstr>
      <vt:lpstr>Arial Unicode MS</vt:lpstr>
      <vt:lpstr>Arial</vt:lpstr>
      <vt:lpstr>Calibri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>AS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Joe</dc:creator>
  <cp:lastModifiedBy>Microsoft Office 使用者</cp:lastModifiedBy>
  <cp:revision>148</cp:revision>
  <cp:lastPrinted>2020-01-15T05:09:44Z</cp:lastPrinted>
  <dcterms:created xsi:type="dcterms:W3CDTF">2013-01-16T05:25:52Z</dcterms:created>
  <dcterms:modified xsi:type="dcterms:W3CDTF">2021-06-10T03:07:24Z</dcterms:modified>
</cp:coreProperties>
</file>